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CFF"/>
    <a:srgbClr val="99FF33"/>
    <a:srgbClr val="F4B183"/>
    <a:srgbClr val="B4C7E7"/>
    <a:srgbClr val="FFC00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>
        <p:scale>
          <a:sx n="110" d="100"/>
          <a:sy n="110" d="100"/>
        </p:scale>
        <p:origin x="-2478" y="-12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5403F-95A8-4A3C-952F-3C6D11455696}" type="datetimeFigureOut">
              <a:rPr lang="en-US" smtClean="0"/>
              <a:pPr/>
              <a:t>2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C9009-CC8B-4E1C-808D-82B0BB9234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36965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5403F-95A8-4A3C-952F-3C6D11455696}" type="datetimeFigureOut">
              <a:rPr lang="en-US" smtClean="0"/>
              <a:pPr/>
              <a:t>2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C9009-CC8B-4E1C-808D-82B0BB9234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9877825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5403F-95A8-4A3C-952F-3C6D11455696}" type="datetimeFigureOut">
              <a:rPr lang="en-US" smtClean="0"/>
              <a:pPr/>
              <a:t>2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C9009-CC8B-4E1C-808D-82B0BB9234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321045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5403F-95A8-4A3C-952F-3C6D11455696}" type="datetimeFigureOut">
              <a:rPr lang="en-US" smtClean="0"/>
              <a:pPr/>
              <a:t>2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C9009-CC8B-4E1C-808D-82B0BB9234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416712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5403F-95A8-4A3C-952F-3C6D11455696}" type="datetimeFigureOut">
              <a:rPr lang="en-US" smtClean="0"/>
              <a:pPr/>
              <a:t>2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C9009-CC8B-4E1C-808D-82B0BB9234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865833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5403F-95A8-4A3C-952F-3C6D11455696}" type="datetimeFigureOut">
              <a:rPr lang="en-US" smtClean="0"/>
              <a:pPr/>
              <a:t>2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C9009-CC8B-4E1C-808D-82B0BB9234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379941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5403F-95A8-4A3C-952F-3C6D11455696}" type="datetimeFigureOut">
              <a:rPr lang="en-US" smtClean="0"/>
              <a:pPr/>
              <a:t>2/2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C9009-CC8B-4E1C-808D-82B0BB9234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273069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5403F-95A8-4A3C-952F-3C6D11455696}" type="datetimeFigureOut">
              <a:rPr lang="en-US" smtClean="0"/>
              <a:pPr/>
              <a:t>2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C9009-CC8B-4E1C-808D-82B0BB9234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832007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5403F-95A8-4A3C-952F-3C6D11455696}" type="datetimeFigureOut">
              <a:rPr lang="en-US" smtClean="0"/>
              <a:pPr/>
              <a:t>2/2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C9009-CC8B-4E1C-808D-82B0BB9234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49107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5403F-95A8-4A3C-952F-3C6D11455696}" type="datetimeFigureOut">
              <a:rPr lang="en-US" smtClean="0"/>
              <a:pPr/>
              <a:t>2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C9009-CC8B-4E1C-808D-82B0BB9234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76566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5403F-95A8-4A3C-952F-3C6D11455696}" type="datetimeFigureOut">
              <a:rPr lang="en-US" smtClean="0"/>
              <a:pPr/>
              <a:t>2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C9009-CC8B-4E1C-808D-82B0BB9234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582098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B5403F-95A8-4A3C-952F-3C6D11455696}" type="datetimeFigureOut">
              <a:rPr lang="en-US" smtClean="0"/>
              <a:pPr/>
              <a:t>2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AC9009-CC8B-4E1C-808D-82B0BB9234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7324406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74516" y="290752"/>
            <a:ext cx="806409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1. Figure S1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chematic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tructure of 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vCSP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123378063"/>
              </p:ext>
            </p:extLst>
          </p:nvPr>
        </p:nvGraphicFramePr>
        <p:xfrm>
          <a:off x="509471" y="3429552"/>
          <a:ext cx="8111994" cy="47560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556637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1556637"/>
              </a:tblGrid>
              <a:tr h="475606"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latin typeface="Arial" pitchFamily="34" charset="0"/>
                          <a:cs typeface="Arial" pitchFamily="34" charset="0"/>
                        </a:rPr>
                        <a:t>N-terminal</a:t>
                      </a:r>
                      <a:endParaRPr lang="en-US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solidFill>
                      <a:srgbClr val="B4C7E7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latin typeface="Arial" pitchFamily="34" charset="0"/>
                          <a:cs typeface="Arial" pitchFamily="34" charset="0"/>
                        </a:rPr>
                        <a:t>C-terminal</a:t>
                      </a:r>
                      <a:endParaRPr lang="en-US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solidFill>
                      <a:srgbClr val="FFCCFF"/>
                    </a:solidFill>
                  </a:tcPr>
                </a:tc>
              </a:tr>
            </a:tbl>
          </a:graphicData>
        </a:graphic>
      </p:graphicFrame>
      <p:sp>
        <p:nvSpPr>
          <p:cNvPr id="23" name="Left Bracket 22"/>
          <p:cNvSpPr/>
          <p:nvPr/>
        </p:nvSpPr>
        <p:spPr>
          <a:xfrm rot="5400000">
            <a:off x="4476798" y="756263"/>
            <a:ext cx="173421" cy="4988564"/>
          </a:xfrm>
          <a:prstGeom prst="leftBracket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029945" y="2782763"/>
            <a:ext cx="30700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entral repeat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region (CRR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직사각형 19"/>
          <p:cNvSpPr/>
          <p:nvPr/>
        </p:nvSpPr>
        <p:spPr>
          <a:xfrm>
            <a:off x="3320657" y="3915327"/>
            <a:ext cx="253306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Peptide repeat motifs (PRMs)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0815470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1</TotalTime>
  <Words>25</Words>
  <Application>Microsoft Office PowerPoint</Application>
  <PresentationFormat>화면 슬라이드 쇼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Theme</vt:lpstr>
      <vt:lpstr>슬라이드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g</dc:creator>
  <cp:lastModifiedBy>GSNU</cp:lastModifiedBy>
  <cp:revision>17</cp:revision>
  <dcterms:created xsi:type="dcterms:W3CDTF">2019-12-16T12:42:01Z</dcterms:created>
  <dcterms:modified xsi:type="dcterms:W3CDTF">2020-02-29T03:22:04Z</dcterms:modified>
</cp:coreProperties>
</file>